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notesMasterIdLst>
    <p:notesMasterId r:id="rId5"/>
  </p:notesMasterIdLst>
  <p:sldIdLst>
    <p:sldId id="338" r:id="rId2"/>
    <p:sldId id="343" r:id="rId3"/>
    <p:sldId id="345" r:id="rId4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6" userDrawn="1">
          <p15:clr>
            <a:srgbClr val="A4A3A4"/>
          </p15:clr>
        </p15:guide>
        <p15:guide id="2" pos="3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41" autoAdjust="0"/>
    <p:restoredTop sz="96015" autoAdjust="0"/>
  </p:normalViewPr>
  <p:slideViewPr>
    <p:cSldViewPr snapToGrid="0">
      <p:cViewPr varScale="1">
        <p:scale>
          <a:sx n="96" d="100"/>
          <a:sy n="96" d="100"/>
        </p:scale>
        <p:origin x="2712" y="102"/>
      </p:cViewPr>
      <p:guideLst>
        <p:guide orient="horz" pos="456"/>
        <p:guide pos="3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h, SangKon, Ph.D." userId="a100f653-236a-4e63-a363-ecec6c31ce4d" providerId="ADAL" clId="{07ED583C-8565-4F26-924B-276E53815C8D}"/>
    <pc:docChg chg="undo custSel delSld modSld">
      <pc:chgData name="Oh, SangKon, Ph.D." userId="a100f653-236a-4e63-a363-ecec6c31ce4d" providerId="ADAL" clId="{07ED583C-8565-4F26-924B-276E53815C8D}" dt="2025-03-28T16:01:14.699" v="98" actId="1036"/>
      <pc:docMkLst>
        <pc:docMk/>
      </pc:docMkLst>
      <pc:sldChg chg="addSp delSp modSp del mod">
        <pc:chgData name="Oh, SangKon, Ph.D." userId="a100f653-236a-4e63-a363-ecec6c31ce4d" providerId="ADAL" clId="{07ED583C-8565-4F26-924B-276E53815C8D}" dt="2025-03-28T16:00:35.041" v="8" actId="2696"/>
        <pc:sldMkLst>
          <pc:docMk/>
          <pc:sldMk cId="3616204674" sldId="344"/>
        </pc:sldMkLst>
        <pc:spChg chg="add del">
          <ac:chgData name="Oh, SangKon, Ph.D." userId="a100f653-236a-4e63-a363-ecec6c31ce4d" providerId="ADAL" clId="{07ED583C-8565-4F26-924B-276E53815C8D}" dt="2025-03-28T15:59:02.975" v="6" actId="478"/>
          <ac:spMkLst>
            <pc:docMk/>
            <pc:sldMk cId="3616204674" sldId="344"/>
            <ac:spMk id="2" creationId="{BCEE6BD4-1205-1702-C299-561229034190}"/>
          </ac:spMkLst>
        </pc:spChg>
        <pc:spChg chg="add del">
          <ac:chgData name="Oh, SangKon, Ph.D." userId="a100f653-236a-4e63-a363-ecec6c31ce4d" providerId="ADAL" clId="{07ED583C-8565-4F26-924B-276E53815C8D}" dt="2025-03-28T15:59:03.866" v="7" actId="478"/>
          <ac:spMkLst>
            <pc:docMk/>
            <pc:sldMk cId="3616204674" sldId="344"/>
            <ac:spMk id="3" creationId="{07D2DA5C-8D00-6C86-0E62-5B1E50F643B6}"/>
          </ac:spMkLst>
        </pc:spChg>
        <pc:cxnChg chg="add del">
          <ac:chgData name="Oh, SangKon, Ph.D." userId="a100f653-236a-4e63-a363-ecec6c31ce4d" providerId="ADAL" clId="{07ED583C-8565-4F26-924B-276E53815C8D}" dt="2025-03-28T15:59:03.866" v="7" actId="478"/>
          <ac:cxnSpMkLst>
            <pc:docMk/>
            <pc:sldMk cId="3616204674" sldId="344"/>
            <ac:cxnSpMk id="4" creationId="{929C9E53-1536-AAF9-E72A-1EBC143F01DA}"/>
          </ac:cxnSpMkLst>
        </pc:cxnChg>
        <pc:cxnChg chg="add del mod">
          <ac:chgData name="Oh, SangKon, Ph.D." userId="a100f653-236a-4e63-a363-ecec6c31ce4d" providerId="ADAL" clId="{07ED583C-8565-4F26-924B-276E53815C8D}" dt="2025-03-28T15:59:02.375" v="5" actId="1076"/>
          <ac:cxnSpMkLst>
            <pc:docMk/>
            <pc:sldMk cId="3616204674" sldId="344"/>
            <ac:cxnSpMk id="6" creationId="{A576B94C-2AE0-61BB-C51C-EB0452C8D630}"/>
          </ac:cxnSpMkLst>
        </pc:cxnChg>
      </pc:sldChg>
      <pc:sldChg chg="addSp modSp mod">
        <pc:chgData name="Oh, SangKon, Ph.D." userId="a100f653-236a-4e63-a363-ecec6c31ce4d" providerId="ADAL" clId="{07ED583C-8565-4F26-924B-276E53815C8D}" dt="2025-03-28T16:01:14.699" v="98" actId="1036"/>
        <pc:sldMkLst>
          <pc:docMk/>
          <pc:sldMk cId="1166736684" sldId="345"/>
        </pc:sldMkLst>
        <pc:cxnChg chg="add mod">
          <ac:chgData name="Oh, SangKon, Ph.D." userId="a100f653-236a-4e63-a363-ecec6c31ce4d" providerId="ADAL" clId="{07ED583C-8565-4F26-924B-276E53815C8D}" dt="2025-03-28T16:01:14.699" v="98" actId="1036"/>
          <ac:cxnSpMkLst>
            <pc:docMk/>
            <pc:sldMk cId="1166736684" sldId="345"/>
            <ac:cxnSpMk id="4" creationId="{6C4A5B06-3F2C-2467-90E4-F9115FD8A66A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762540E3-2B3C-4C5B-8DB5-E71F7F4C89FD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D68051D-4CEB-45D8-B99D-1FC6BC241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9887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339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699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623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217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662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135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472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152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827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924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901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470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9208D66-806F-3A1E-6DA3-617C6BC5FD5A}"/>
              </a:ext>
            </a:extLst>
          </p:cNvPr>
          <p:cNvSpPr txBox="1"/>
          <p:nvPr/>
        </p:nvSpPr>
        <p:spPr>
          <a:xfrm>
            <a:off x="509048" y="641601"/>
            <a:ext cx="1817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s for: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23A5AA0-7803-6977-6905-263932FA89F1}"/>
              </a:ext>
            </a:extLst>
          </p:cNvPr>
          <p:cNvSpPr txBox="1"/>
          <p:nvPr/>
        </p:nvSpPr>
        <p:spPr>
          <a:xfrm>
            <a:off x="366173" y="1135919"/>
            <a:ext cx="616513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malizumab controls surface phenotypes of dendritic cells and monocytes in asthm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B6923E2-C7B2-F931-7155-B2B0A14CFFD0}"/>
              </a:ext>
            </a:extLst>
          </p:cNvPr>
          <p:cNvSpPr txBox="1"/>
          <p:nvPr/>
        </p:nvSpPr>
        <p:spPr>
          <a:xfrm>
            <a:off x="509048" y="2321485"/>
            <a:ext cx="573331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*AY, LB, and KU equally contribute to this study</a:t>
            </a: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Department of Immunology, Mayo Clinic, Scottsdale, AZ</a:t>
            </a: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2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Baylor University, Institute for Biomedical Studies, Waco, TX </a:t>
            </a: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3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Martha Foster Lung Care Center, Baylor University Medical Center, Dallas, TX </a:t>
            </a: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C3D117-4617-516F-95A9-DAEB5E676479}"/>
              </a:ext>
            </a:extLst>
          </p:cNvPr>
          <p:cNvSpPr txBox="1"/>
          <p:nvPr/>
        </p:nvSpPr>
        <p:spPr>
          <a:xfrm>
            <a:off x="509048" y="1886903"/>
            <a:ext cx="583990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gnes Yang, BS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*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Laurie Baert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*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Katherine Upchurch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2*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Mark Millard, M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3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Matthew Wiest</a:t>
            </a:r>
            <a:r>
              <a:rPr lang="en-US" sz="120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, PhD</a:t>
            </a:r>
            <a:r>
              <a:rPr lang="en-US" sz="1200" baseline="3000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kern="100" baseline="3000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</a:t>
            </a:r>
            <a:r>
              <a:rPr lang="en-US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200" kern="10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hao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u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HyeMee Joo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and SangKon Oh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 2</a:t>
            </a:r>
            <a:endParaRPr lang="en-US" sz="1200" kern="1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D0595165-2A27-C339-A170-1FA36914E7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6517768"/>
              </p:ext>
            </p:extLst>
          </p:nvPr>
        </p:nvGraphicFramePr>
        <p:xfrm>
          <a:off x="537623" y="3762375"/>
          <a:ext cx="5876189" cy="13185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74725">
                  <a:extLst>
                    <a:ext uri="{9D8B030D-6E8A-4147-A177-3AD203B41FA5}">
                      <a16:colId xmlns:a16="http://schemas.microsoft.com/office/drawing/2014/main" val="3532298759"/>
                    </a:ext>
                  </a:extLst>
                </a:gridCol>
                <a:gridCol w="5101464">
                  <a:extLst>
                    <a:ext uri="{9D8B030D-6E8A-4147-A177-3AD203B41FA5}">
                      <a16:colId xmlns:a16="http://schemas.microsoft.com/office/drawing/2014/main" val="4185052639"/>
                    </a:ext>
                  </a:extLst>
                </a:gridCol>
              </a:tblGrid>
              <a:tr h="430234">
                <a:tc gridSpan="2"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upplemental Information includes:</a:t>
                      </a:r>
                    </a:p>
                    <a:p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8103241"/>
                  </a:ext>
                </a:extLst>
              </a:tr>
              <a:tr h="40417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ble E1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Characteristics of asthma patients and non-asthmatic control subjects recruited in this study.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6648439"/>
                  </a:ext>
                </a:extLst>
              </a:tr>
              <a:tr h="40417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ble E2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List of antibodies used in this study.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28290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2561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B16DFB4-205C-2E4B-381A-A187468408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7098" y="765429"/>
            <a:ext cx="5957316" cy="21076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24378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7B8E3B7-737B-D25B-68DA-13095FBF59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4200" y="736600"/>
            <a:ext cx="5957316" cy="5097780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6C4A5B06-3F2C-2467-90E4-F9115FD8A66A}"/>
              </a:ext>
            </a:extLst>
          </p:cNvPr>
          <p:cNvCxnSpPr/>
          <p:nvPr/>
        </p:nvCxnSpPr>
        <p:spPr>
          <a:xfrm>
            <a:off x="584200" y="5665293"/>
            <a:ext cx="43356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6736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442</TotalTime>
  <Words>136</Words>
  <Application>Microsoft Office PowerPoint</Application>
  <PresentationFormat>On-screen Show (4:3)</PresentationFormat>
  <Paragraphs>1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g, Agnes</dc:creator>
  <cp:lastModifiedBy>Oh, SangKon, Ph.D.</cp:lastModifiedBy>
  <cp:revision>994</cp:revision>
  <cp:lastPrinted>2024-12-13T18:10:04Z</cp:lastPrinted>
  <dcterms:created xsi:type="dcterms:W3CDTF">2024-07-19T21:44:25Z</dcterms:created>
  <dcterms:modified xsi:type="dcterms:W3CDTF">2025-03-28T16:01:15Z</dcterms:modified>
</cp:coreProperties>
</file>